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2" d="100"/>
          <a:sy n="62" d="100"/>
        </p:scale>
        <p:origin x="804"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hosh, Souvik" userId="eecea02d-3ead-4d19-9bc6-c58aca595acd" providerId="ADAL" clId="{0EB3F3F4-0E34-4843-93E6-115DF632223B}"/>
    <pc:docChg chg="undo custSel addSld delSld modSld">
      <pc:chgData name="Ghosh, Souvik" userId="eecea02d-3ead-4d19-9bc6-c58aca595acd" providerId="ADAL" clId="{0EB3F3F4-0E34-4843-93E6-115DF632223B}" dt="2024-03-02T14:45:07.804" v="1387" actId="20577"/>
      <pc:docMkLst>
        <pc:docMk/>
      </pc:docMkLst>
      <pc:sldChg chg="addSp delSp modSp new mod">
        <pc:chgData name="Ghosh, Souvik" userId="eecea02d-3ead-4d19-9bc6-c58aca595acd" providerId="ADAL" clId="{0EB3F3F4-0E34-4843-93E6-115DF632223B}" dt="2024-03-02T14:45:07.804" v="1387" actId="20577"/>
        <pc:sldMkLst>
          <pc:docMk/>
          <pc:sldMk cId="1529973736" sldId="256"/>
        </pc:sldMkLst>
        <pc:spChg chg="add del mod">
          <ac:chgData name="Ghosh, Souvik" userId="eecea02d-3ead-4d19-9bc6-c58aca595acd" providerId="ADAL" clId="{0EB3F3F4-0E34-4843-93E6-115DF632223B}" dt="2024-03-01T13:58:02.332" v="1180" actId="478"/>
          <ac:spMkLst>
            <pc:docMk/>
            <pc:sldMk cId="1529973736" sldId="256"/>
            <ac:spMk id="12" creationId="{303CF874-7432-DF13-E9F7-1C52ABB0856C}"/>
          </ac:spMkLst>
        </pc:spChg>
        <pc:spChg chg="add del mod">
          <ac:chgData name="Ghosh, Souvik" userId="eecea02d-3ead-4d19-9bc6-c58aca595acd" providerId="ADAL" clId="{0EB3F3F4-0E34-4843-93E6-115DF632223B}" dt="2024-03-01T13:51:46.777" v="1090" actId="21"/>
          <ac:spMkLst>
            <pc:docMk/>
            <pc:sldMk cId="1529973736" sldId="256"/>
            <ac:spMk id="19" creationId="{E01518B9-A8FA-AEF5-1635-0837B7B5B5A2}"/>
          </ac:spMkLst>
        </pc:spChg>
        <pc:spChg chg="add del mod">
          <ac:chgData name="Ghosh, Souvik" userId="eecea02d-3ead-4d19-9bc6-c58aca595acd" providerId="ADAL" clId="{0EB3F3F4-0E34-4843-93E6-115DF632223B}" dt="2024-03-01T13:58:36.854" v="1183" actId="21"/>
          <ac:spMkLst>
            <pc:docMk/>
            <pc:sldMk cId="1529973736" sldId="256"/>
            <ac:spMk id="21" creationId="{A96D8890-2803-736E-110A-53C72A194646}"/>
          </ac:spMkLst>
        </pc:spChg>
        <pc:spChg chg="add del mod">
          <ac:chgData name="Ghosh, Souvik" userId="eecea02d-3ead-4d19-9bc6-c58aca595acd" providerId="ADAL" clId="{0EB3F3F4-0E34-4843-93E6-115DF632223B}" dt="2024-03-01T13:58:36.854" v="1183" actId="21"/>
          <ac:spMkLst>
            <pc:docMk/>
            <pc:sldMk cId="1529973736" sldId="256"/>
            <ac:spMk id="22" creationId="{750C446F-DB1E-3FDD-D493-A6F46276CA14}"/>
          </ac:spMkLst>
        </pc:spChg>
        <pc:spChg chg="add del mod">
          <ac:chgData name="Ghosh, Souvik" userId="eecea02d-3ead-4d19-9bc6-c58aca595acd" providerId="ADAL" clId="{0EB3F3F4-0E34-4843-93E6-115DF632223B}" dt="2024-03-01T13:58:36.854" v="1183" actId="21"/>
          <ac:spMkLst>
            <pc:docMk/>
            <pc:sldMk cId="1529973736" sldId="256"/>
            <ac:spMk id="23" creationId="{3275D293-66E5-5D5B-CC71-8DF0E99AAD0B}"/>
          </ac:spMkLst>
        </pc:spChg>
        <pc:spChg chg="add del mod">
          <ac:chgData name="Ghosh, Souvik" userId="eecea02d-3ead-4d19-9bc6-c58aca595acd" providerId="ADAL" clId="{0EB3F3F4-0E34-4843-93E6-115DF632223B}" dt="2024-03-01T13:58:36.854" v="1183" actId="21"/>
          <ac:spMkLst>
            <pc:docMk/>
            <pc:sldMk cId="1529973736" sldId="256"/>
            <ac:spMk id="24" creationId="{EB6B5328-463D-BE6E-43D1-338B12804493}"/>
          </ac:spMkLst>
        </pc:spChg>
        <pc:spChg chg="add del mod">
          <ac:chgData name="Ghosh, Souvik" userId="eecea02d-3ead-4d19-9bc6-c58aca595acd" providerId="ADAL" clId="{0EB3F3F4-0E34-4843-93E6-115DF632223B}" dt="2024-03-01T13:58:36.854" v="1183" actId="21"/>
          <ac:spMkLst>
            <pc:docMk/>
            <pc:sldMk cId="1529973736" sldId="256"/>
            <ac:spMk id="25" creationId="{228ABC91-2271-C35F-B70C-1F4B398FEDFC}"/>
          </ac:spMkLst>
        </pc:spChg>
        <pc:spChg chg="add mod">
          <ac:chgData name="Ghosh, Souvik" userId="eecea02d-3ead-4d19-9bc6-c58aca595acd" providerId="ADAL" clId="{0EB3F3F4-0E34-4843-93E6-115DF632223B}" dt="2024-03-02T14:45:07.804" v="1387" actId="20577"/>
          <ac:spMkLst>
            <pc:docMk/>
            <pc:sldMk cId="1529973736" sldId="256"/>
            <ac:spMk id="27" creationId="{59EB5FD1-9CEE-1585-1C83-7DB3BCD900BE}"/>
          </ac:spMkLst>
        </pc:spChg>
        <pc:spChg chg="add mod">
          <ac:chgData name="Ghosh, Souvik" userId="eecea02d-3ead-4d19-9bc6-c58aca595acd" providerId="ADAL" clId="{0EB3F3F4-0E34-4843-93E6-115DF632223B}" dt="2024-03-01T14:09:36.224" v="1291" actId="20577"/>
          <ac:spMkLst>
            <pc:docMk/>
            <pc:sldMk cId="1529973736" sldId="256"/>
            <ac:spMk id="28" creationId="{541E1773-3712-3D6C-12FE-81B4918828BF}"/>
          </ac:spMkLst>
        </pc:spChg>
        <pc:picChg chg="add del mod">
          <ac:chgData name="Ghosh, Souvik" userId="eecea02d-3ead-4d19-9bc6-c58aca595acd" providerId="ADAL" clId="{0EB3F3F4-0E34-4843-93E6-115DF632223B}" dt="2024-03-01T12:18:44.371" v="5" actId="478"/>
          <ac:picMkLst>
            <pc:docMk/>
            <pc:sldMk cId="1529973736" sldId="256"/>
            <ac:picMk id="3" creationId="{A84EBF88-B977-FCDC-3151-522CDC697C82}"/>
          </ac:picMkLst>
        </pc:picChg>
        <pc:picChg chg="add del mod">
          <ac:chgData name="Ghosh, Souvik" userId="eecea02d-3ead-4d19-9bc6-c58aca595acd" providerId="ADAL" clId="{0EB3F3F4-0E34-4843-93E6-115DF632223B}" dt="2024-03-01T12:20:23.880" v="9" actId="478"/>
          <ac:picMkLst>
            <pc:docMk/>
            <pc:sldMk cId="1529973736" sldId="256"/>
            <ac:picMk id="5" creationId="{257AFC9F-498D-3BA8-2B5B-23E7E3478083}"/>
          </ac:picMkLst>
        </pc:picChg>
        <pc:picChg chg="add del mod">
          <ac:chgData name="Ghosh, Souvik" userId="eecea02d-3ead-4d19-9bc6-c58aca595acd" providerId="ADAL" clId="{0EB3F3F4-0E34-4843-93E6-115DF632223B}" dt="2024-03-01T12:21:03.965" v="18" actId="478"/>
          <ac:picMkLst>
            <pc:docMk/>
            <pc:sldMk cId="1529973736" sldId="256"/>
            <ac:picMk id="7" creationId="{86DB9567-0160-0461-89FD-EA38830E83A4}"/>
          </ac:picMkLst>
        </pc:picChg>
        <pc:picChg chg="add del mod">
          <ac:chgData name="Ghosh, Souvik" userId="eecea02d-3ead-4d19-9bc6-c58aca595acd" providerId="ADAL" clId="{0EB3F3F4-0E34-4843-93E6-115DF632223B}" dt="2024-03-01T12:23:56.447" v="22" actId="478"/>
          <ac:picMkLst>
            <pc:docMk/>
            <pc:sldMk cId="1529973736" sldId="256"/>
            <ac:picMk id="9" creationId="{296DF66B-4A0B-AF8B-891A-5B32E7A3503D}"/>
          </ac:picMkLst>
        </pc:picChg>
        <pc:picChg chg="add del mod">
          <ac:chgData name="Ghosh, Souvik" userId="eecea02d-3ead-4d19-9bc6-c58aca595acd" providerId="ADAL" clId="{0EB3F3F4-0E34-4843-93E6-115DF632223B}" dt="2024-03-01T12:46:07.933" v="342" actId="478"/>
          <ac:picMkLst>
            <pc:docMk/>
            <pc:sldMk cId="1529973736" sldId="256"/>
            <ac:picMk id="11" creationId="{E699FDBD-AD4F-109C-7687-BB468559CB61}"/>
          </ac:picMkLst>
        </pc:picChg>
        <pc:picChg chg="add del mod">
          <ac:chgData name="Ghosh, Souvik" userId="eecea02d-3ead-4d19-9bc6-c58aca595acd" providerId="ADAL" clId="{0EB3F3F4-0E34-4843-93E6-115DF632223B}" dt="2024-03-01T13:47:10.032" v="1059" actId="478"/>
          <ac:picMkLst>
            <pc:docMk/>
            <pc:sldMk cId="1529973736" sldId="256"/>
            <ac:picMk id="14" creationId="{B89CD9AB-C398-CF74-8240-F345A043BF10}"/>
          </ac:picMkLst>
        </pc:picChg>
        <pc:picChg chg="add del mod">
          <ac:chgData name="Ghosh, Souvik" userId="eecea02d-3ead-4d19-9bc6-c58aca595acd" providerId="ADAL" clId="{0EB3F3F4-0E34-4843-93E6-115DF632223B}" dt="2024-03-01T13:49:54.127" v="1079" actId="478"/>
          <ac:picMkLst>
            <pc:docMk/>
            <pc:sldMk cId="1529973736" sldId="256"/>
            <ac:picMk id="16" creationId="{7171E46D-8B13-52C4-D271-04C8C0030840}"/>
          </ac:picMkLst>
        </pc:picChg>
        <pc:picChg chg="add del mod">
          <ac:chgData name="Ghosh, Souvik" userId="eecea02d-3ead-4d19-9bc6-c58aca595acd" providerId="ADAL" clId="{0EB3F3F4-0E34-4843-93E6-115DF632223B}" dt="2024-03-01T13:51:46.777" v="1090" actId="21"/>
          <ac:picMkLst>
            <pc:docMk/>
            <pc:sldMk cId="1529973736" sldId="256"/>
            <ac:picMk id="18" creationId="{B8122E79-AB99-0E3B-6123-621F0068E6DD}"/>
          </ac:picMkLst>
        </pc:picChg>
        <pc:picChg chg="add del mod">
          <ac:chgData name="Ghosh, Souvik" userId="eecea02d-3ead-4d19-9bc6-c58aca595acd" providerId="ADAL" clId="{0EB3F3F4-0E34-4843-93E6-115DF632223B}" dt="2024-03-01T13:58:36.854" v="1183" actId="21"/>
          <ac:picMkLst>
            <pc:docMk/>
            <pc:sldMk cId="1529973736" sldId="256"/>
            <ac:picMk id="20" creationId="{7B222C8B-E962-5E05-ECA4-70B9D0F56D9A}"/>
          </ac:picMkLst>
        </pc:picChg>
        <pc:picChg chg="add mod">
          <ac:chgData name="Ghosh, Souvik" userId="eecea02d-3ead-4d19-9bc6-c58aca595acd" providerId="ADAL" clId="{0EB3F3F4-0E34-4843-93E6-115DF632223B}" dt="2024-03-01T14:12:13.149" v="1324" actId="14100"/>
          <ac:picMkLst>
            <pc:docMk/>
            <pc:sldMk cId="1529973736" sldId="256"/>
            <ac:picMk id="26" creationId="{3589B548-00D8-F5FF-395C-F66B04F6E3EE}"/>
          </ac:picMkLst>
        </pc:picChg>
      </pc:sldChg>
      <pc:sldChg chg="addSp delSp modSp new del mod">
        <pc:chgData name="Ghosh, Souvik" userId="eecea02d-3ead-4d19-9bc6-c58aca595acd" providerId="ADAL" clId="{0EB3F3F4-0E34-4843-93E6-115DF632223B}" dt="2024-03-01T14:09:44.801" v="1292" actId="2696"/>
        <pc:sldMkLst>
          <pc:docMk/>
          <pc:sldMk cId="900902259" sldId="257"/>
        </pc:sldMkLst>
        <pc:spChg chg="add del mod">
          <ac:chgData name="Ghosh, Souvik" userId="eecea02d-3ead-4d19-9bc6-c58aca595acd" providerId="ADAL" clId="{0EB3F3F4-0E34-4843-93E6-115DF632223B}" dt="2024-03-01T13:58:50.524" v="1185" actId="21"/>
          <ac:spMkLst>
            <pc:docMk/>
            <pc:sldMk cId="900902259" sldId="257"/>
            <ac:spMk id="2" creationId="{59EB5FD1-9CEE-1585-1C83-7DB3BCD900BE}"/>
          </ac:spMkLst>
        </pc:spChg>
      </pc:sldChg>
    </pc:docChg>
  </pc:docChgLst>
  <pc:docChgLst>
    <pc:chgData name="Ghosh, Souvik" userId="eecea02d-3ead-4d19-9bc6-c58aca595acd" providerId="ADAL" clId="{9F0E628E-8835-4296-9287-43DE8DEC1680}"/>
    <pc:docChg chg="custSel addSld delSld modSld">
      <pc:chgData name="Ghosh, Souvik" userId="eecea02d-3ead-4d19-9bc6-c58aca595acd" providerId="ADAL" clId="{9F0E628E-8835-4296-9287-43DE8DEC1680}" dt="2024-03-03T14:38:36.689" v="115" actId="6549"/>
      <pc:docMkLst>
        <pc:docMk/>
      </pc:docMkLst>
      <pc:sldChg chg="addSp delSp modSp mod">
        <pc:chgData name="Ghosh, Souvik" userId="eecea02d-3ead-4d19-9bc6-c58aca595acd" providerId="ADAL" clId="{9F0E628E-8835-4296-9287-43DE8DEC1680}" dt="2024-03-03T14:38:36.689" v="115" actId="6549"/>
        <pc:sldMkLst>
          <pc:docMk/>
          <pc:sldMk cId="1529973736" sldId="256"/>
        </pc:sldMkLst>
        <pc:spChg chg="add del mod">
          <ac:chgData name="Ghosh, Souvik" userId="eecea02d-3ead-4d19-9bc6-c58aca595acd" providerId="ADAL" clId="{9F0E628E-8835-4296-9287-43DE8DEC1680}" dt="2024-03-03T14:29:36.866" v="104" actId="478"/>
          <ac:spMkLst>
            <pc:docMk/>
            <pc:sldMk cId="1529973736" sldId="256"/>
            <ac:spMk id="6" creationId="{ABB608C7-A802-DADC-7A5E-D7476370C957}"/>
          </ac:spMkLst>
        </pc:spChg>
        <pc:spChg chg="add del mod">
          <ac:chgData name="Ghosh, Souvik" userId="eecea02d-3ead-4d19-9bc6-c58aca595acd" providerId="ADAL" clId="{9F0E628E-8835-4296-9287-43DE8DEC1680}" dt="2024-03-03T14:29:39.792" v="106" actId="478"/>
          <ac:spMkLst>
            <pc:docMk/>
            <pc:sldMk cId="1529973736" sldId="256"/>
            <ac:spMk id="7" creationId="{6AC5CB0A-D927-A6FA-F3FE-A98A8C05BC7E}"/>
          </ac:spMkLst>
        </pc:spChg>
        <pc:spChg chg="add del mod">
          <ac:chgData name="Ghosh, Souvik" userId="eecea02d-3ead-4d19-9bc6-c58aca595acd" providerId="ADAL" clId="{9F0E628E-8835-4296-9287-43DE8DEC1680}" dt="2024-03-03T14:29:38.308" v="105" actId="478"/>
          <ac:spMkLst>
            <pc:docMk/>
            <pc:sldMk cId="1529973736" sldId="256"/>
            <ac:spMk id="8" creationId="{06580F43-3E66-DF10-B6AC-28E9C67238AC}"/>
          </ac:spMkLst>
        </pc:spChg>
        <pc:spChg chg="add del mod">
          <ac:chgData name="Ghosh, Souvik" userId="eecea02d-3ead-4d19-9bc6-c58aca595acd" providerId="ADAL" clId="{9F0E628E-8835-4296-9287-43DE8DEC1680}" dt="2024-03-03T14:29:41.234" v="107" actId="478"/>
          <ac:spMkLst>
            <pc:docMk/>
            <pc:sldMk cId="1529973736" sldId="256"/>
            <ac:spMk id="9" creationId="{13C1E6E0-1546-F5B9-2706-C8B4F78FE47F}"/>
          </ac:spMkLst>
        </pc:spChg>
        <pc:spChg chg="mod">
          <ac:chgData name="Ghosh, Souvik" userId="eecea02d-3ead-4d19-9bc6-c58aca595acd" providerId="ADAL" clId="{9F0E628E-8835-4296-9287-43DE8DEC1680}" dt="2024-03-03T14:38:36.689" v="115" actId="6549"/>
          <ac:spMkLst>
            <pc:docMk/>
            <pc:sldMk cId="1529973736" sldId="256"/>
            <ac:spMk id="27" creationId="{59EB5FD1-9CEE-1585-1C83-7DB3BCD900BE}"/>
          </ac:spMkLst>
        </pc:spChg>
        <pc:picChg chg="add del mod">
          <ac:chgData name="Ghosh, Souvik" userId="eecea02d-3ead-4d19-9bc6-c58aca595acd" providerId="ADAL" clId="{9F0E628E-8835-4296-9287-43DE8DEC1680}" dt="2024-03-03T14:22:56.458" v="20" actId="478"/>
          <ac:picMkLst>
            <pc:docMk/>
            <pc:sldMk cId="1529973736" sldId="256"/>
            <ac:picMk id="2" creationId="{9CAEF48A-F40B-04C4-5B11-29084EE6B53F}"/>
          </ac:picMkLst>
        </pc:picChg>
        <pc:picChg chg="add del mod">
          <ac:chgData name="Ghosh, Souvik" userId="eecea02d-3ead-4d19-9bc6-c58aca595acd" providerId="ADAL" clId="{9F0E628E-8835-4296-9287-43DE8DEC1680}" dt="2024-03-03T14:24:46.497" v="25" actId="478"/>
          <ac:picMkLst>
            <pc:docMk/>
            <pc:sldMk cId="1529973736" sldId="256"/>
            <ac:picMk id="3" creationId="{31DAB20D-B47E-26DF-1D77-1B9AA588A9B6}"/>
          </ac:picMkLst>
        </pc:picChg>
        <pc:picChg chg="add del mod">
          <ac:chgData name="Ghosh, Souvik" userId="eecea02d-3ead-4d19-9bc6-c58aca595acd" providerId="ADAL" clId="{9F0E628E-8835-4296-9287-43DE8DEC1680}" dt="2024-03-03T14:29:35.431" v="103" actId="478"/>
          <ac:picMkLst>
            <pc:docMk/>
            <pc:sldMk cId="1529973736" sldId="256"/>
            <ac:picMk id="5" creationId="{BB95934B-D359-2780-8775-654FDEBB6436}"/>
          </ac:picMkLst>
        </pc:picChg>
        <pc:picChg chg="add mod">
          <ac:chgData name="Ghosh, Souvik" userId="eecea02d-3ead-4d19-9bc6-c58aca595acd" providerId="ADAL" clId="{9F0E628E-8835-4296-9287-43DE8DEC1680}" dt="2024-03-03T14:30:01.971" v="112" actId="14100"/>
          <ac:picMkLst>
            <pc:docMk/>
            <pc:sldMk cId="1529973736" sldId="256"/>
            <ac:picMk id="10" creationId="{3844B63B-0C58-2111-CB69-3845506FDF20}"/>
          </ac:picMkLst>
        </pc:picChg>
        <pc:picChg chg="del">
          <ac:chgData name="Ghosh, Souvik" userId="eecea02d-3ead-4d19-9bc6-c58aca595acd" providerId="ADAL" clId="{9F0E628E-8835-4296-9287-43DE8DEC1680}" dt="2024-03-03T14:21:54.965" v="3" actId="478"/>
          <ac:picMkLst>
            <pc:docMk/>
            <pc:sldMk cId="1529973736" sldId="256"/>
            <ac:picMk id="26" creationId="{3589B548-00D8-F5FF-395C-F66B04F6E3EE}"/>
          </ac:picMkLst>
        </pc:picChg>
      </pc:sldChg>
      <pc:sldChg chg="addSp new del">
        <pc:chgData name="Ghosh, Souvik" userId="eecea02d-3ead-4d19-9bc6-c58aca595acd" providerId="ADAL" clId="{9F0E628E-8835-4296-9287-43DE8DEC1680}" dt="2024-03-03T14:30:10.049" v="113" actId="2696"/>
        <pc:sldMkLst>
          <pc:docMk/>
          <pc:sldMk cId="3802809343" sldId="257"/>
        </pc:sldMkLst>
        <pc:picChg chg="add">
          <ac:chgData name="Ghosh, Souvik" userId="eecea02d-3ead-4d19-9bc6-c58aca595acd" providerId="ADAL" clId="{9F0E628E-8835-4296-9287-43DE8DEC1680}" dt="2024-03-03T14:29:09.885" v="102"/>
          <ac:picMkLst>
            <pc:docMk/>
            <pc:sldMk cId="3802809343" sldId="257"/>
            <ac:picMk id="2" creationId="{65939B44-442D-21ED-5D87-B296A8C478DC}"/>
          </ac:picMkLst>
        </pc:picChg>
      </pc:sldChg>
    </pc:docChg>
  </pc:docChgLst>
  <pc:docChgLst>
    <pc:chgData name="Ghosh, Souvik" userId="eecea02d-3ead-4d19-9bc6-c58aca595acd" providerId="ADAL" clId="{BB23DCF7-C831-4111-89B5-2FB86E9E0DFF}"/>
    <pc:docChg chg="custSel modSld">
      <pc:chgData name="Ghosh, Souvik" userId="eecea02d-3ead-4d19-9bc6-c58aca595acd" providerId="ADAL" clId="{BB23DCF7-C831-4111-89B5-2FB86E9E0DFF}" dt="2024-03-12T17:09:10.688" v="8" actId="14100"/>
      <pc:docMkLst>
        <pc:docMk/>
      </pc:docMkLst>
      <pc:sldChg chg="delSp modSp mod">
        <pc:chgData name="Ghosh, Souvik" userId="eecea02d-3ead-4d19-9bc6-c58aca595acd" providerId="ADAL" clId="{BB23DCF7-C831-4111-89B5-2FB86E9E0DFF}" dt="2024-03-12T17:09:10.688" v="8" actId="14100"/>
        <pc:sldMkLst>
          <pc:docMk/>
          <pc:sldMk cId="1529973736" sldId="256"/>
        </pc:sldMkLst>
        <pc:spChg chg="mod">
          <ac:chgData name="Ghosh, Souvik" userId="eecea02d-3ead-4d19-9bc6-c58aca595acd" providerId="ADAL" clId="{BB23DCF7-C831-4111-89B5-2FB86E9E0DFF}" dt="2024-03-12T17:08:12.124" v="6" actId="20577"/>
          <ac:spMkLst>
            <pc:docMk/>
            <pc:sldMk cId="1529973736" sldId="256"/>
            <ac:spMk id="27" creationId="{59EB5FD1-9CEE-1585-1C83-7DB3BCD900BE}"/>
          </ac:spMkLst>
        </pc:spChg>
        <pc:spChg chg="del">
          <ac:chgData name="Ghosh, Souvik" userId="eecea02d-3ead-4d19-9bc6-c58aca595acd" providerId="ADAL" clId="{BB23DCF7-C831-4111-89B5-2FB86E9E0DFF}" dt="2024-03-12T17:08:57.805" v="7" actId="478"/>
          <ac:spMkLst>
            <pc:docMk/>
            <pc:sldMk cId="1529973736" sldId="256"/>
            <ac:spMk id="28" creationId="{541E1773-3712-3D6C-12FE-81B4918828BF}"/>
          </ac:spMkLst>
        </pc:spChg>
        <pc:picChg chg="mod">
          <ac:chgData name="Ghosh, Souvik" userId="eecea02d-3ead-4d19-9bc6-c58aca595acd" providerId="ADAL" clId="{BB23DCF7-C831-4111-89B5-2FB86E9E0DFF}" dt="2024-03-12T17:09:10.688" v="8" actId="14100"/>
          <ac:picMkLst>
            <pc:docMk/>
            <pc:sldMk cId="1529973736" sldId="256"/>
            <ac:picMk id="10" creationId="{3844B63B-0C58-2111-CB69-3845506FDF20}"/>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2BFA35-7E92-D0A5-0C1F-5F794F63BF7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B7134EE-DCE4-750E-5274-67A820E7B1E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10D23C9-98A4-16D5-1F8B-03433D234AB3}"/>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5" name="Footer Placeholder 4">
            <a:extLst>
              <a:ext uri="{FF2B5EF4-FFF2-40B4-BE49-F238E27FC236}">
                <a16:creationId xmlns:a16="http://schemas.microsoft.com/office/drawing/2014/main" id="{BE9A0171-319C-5FCE-D1DA-AABAE7B3D6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672382-F954-1617-3A9E-5DA01E734CDF}"/>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2862661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C3E6BF-BFB5-486C-621F-759B1E9FA13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DA5B520-C317-65F2-A819-CE40DAE3488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3D9AA9-D65B-678C-FC2B-C0756DC234E2}"/>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5" name="Footer Placeholder 4">
            <a:extLst>
              <a:ext uri="{FF2B5EF4-FFF2-40B4-BE49-F238E27FC236}">
                <a16:creationId xmlns:a16="http://schemas.microsoft.com/office/drawing/2014/main" id="{0A8115B1-4BAE-EF27-CE30-0ED0AB36707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5228E4D-9532-88DC-EA0D-02E153E68F78}"/>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2440030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8C837B9-D5D0-CA30-7646-E663743B199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F5F789D-95CF-D63E-F5FF-5215C7E30A5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4BB629-D6F1-C9EC-4027-285571833A00}"/>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5" name="Footer Placeholder 4">
            <a:extLst>
              <a:ext uri="{FF2B5EF4-FFF2-40B4-BE49-F238E27FC236}">
                <a16:creationId xmlns:a16="http://schemas.microsoft.com/office/drawing/2014/main" id="{5CCC9CC9-44E1-F693-F94F-D5AF168D7E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93E5C58-6B42-8EBA-8A64-64F8D75D8795}"/>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25669628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B173C0-B057-B133-C140-EF910CF14B9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994821D-67EA-8831-A008-1FDDB4E9C86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03BB4F6-8345-40BF-3D24-0E7912E737D8}"/>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5" name="Footer Placeholder 4">
            <a:extLst>
              <a:ext uri="{FF2B5EF4-FFF2-40B4-BE49-F238E27FC236}">
                <a16:creationId xmlns:a16="http://schemas.microsoft.com/office/drawing/2014/main" id="{CD048A2C-184F-9010-735E-783B3A789D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969BAA-11BF-75FB-3519-9720186C0394}"/>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32984530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2725E5-D281-1A33-BEAB-1E7EAFC3928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84A1393-A97B-AD6D-C1EB-36CC0C4D93C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DAD19BA-31FF-45FD-0AF1-86B4C0FFF564}"/>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5" name="Footer Placeholder 4">
            <a:extLst>
              <a:ext uri="{FF2B5EF4-FFF2-40B4-BE49-F238E27FC236}">
                <a16:creationId xmlns:a16="http://schemas.microsoft.com/office/drawing/2014/main" id="{FA7BD050-6BB6-DF92-A325-3E10CA4D578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5EE3EE6-593B-6184-2992-DEDAA532E9CA}"/>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37127370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FC1213-9109-2C2D-D1A7-6793DB959B7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31C2B73-1ACE-D9BE-CE68-D4B4A4F857C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3CACF00-6F6C-D1D0-4BAD-69A829E3AD6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97012AB-7344-67A2-2527-BBD2D0A3BEDD}"/>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6" name="Footer Placeholder 5">
            <a:extLst>
              <a:ext uri="{FF2B5EF4-FFF2-40B4-BE49-F238E27FC236}">
                <a16:creationId xmlns:a16="http://schemas.microsoft.com/office/drawing/2014/main" id="{223C89A9-B89A-767A-0D3E-8BB6DC9BBB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AED776-D264-308E-6B21-8D00CBD5EC16}"/>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23432962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E21BA5-500D-50F2-F282-E59A8A39D0A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9103128-7796-3110-C7BE-467C7A044E4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CDEC65F-EC7F-F539-4C6D-6E6798DDFAD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93B60C1-BB96-19EC-830B-02685F812E9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E61D257-B0E0-FB6F-D7DC-9935265FBFC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2A394E7-A455-46C7-F3EB-33FD4381650A}"/>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8" name="Footer Placeholder 7">
            <a:extLst>
              <a:ext uri="{FF2B5EF4-FFF2-40B4-BE49-F238E27FC236}">
                <a16:creationId xmlns:a16="http://schemas.microsoft.com/office/drawing/2014/main" id="{1162F81F-CF36-F129-7E71-31F66094DF7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9658CE8-0072-5EF6-B29A-F269D274C1F4}"/>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3406572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5535C3-C745-3A43-7B1E-412EAABFA84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AE252CE-3E6D-13D4-866B-B622BEE08609}"/>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4" name="Footer Placeholder 3">
            <a:extLst>
              <a:ext uri="{FF2B5EF4-FFF2-40B4-BE49-F238E27FC236}">
                <a16:creationId xmlns:a16="http://schemas.microsoft.com/office/drawing/2014/main" id="{367F17D7-A8F2-5A60-0080-31B0F67A65B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73CEE9B-16D6-DAB1-4611-3388B0036CFF}"/>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39717884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022F0C6-DA53-9807-9EA3-3A6661BECFFE}"/>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3" name="Footer Placeholder 2">
            <a:extLst>
              <a:ext uri="{FF2B5EF4-FFF2-40B4-BE49-F238E27FC236}">
                <a16:creationId xmlns:a16="http://schemas.microsoft.com/office/drawing/2014/main" id="{34DF466B-360A-249A-0740-4D4C25C7C1A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F0BF863-288C-93CC-79A4-15089D3D8C4E}"/>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22292318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8D25F5-77BC-9390-801F-63377507084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CC1B08F-845C-426C-239B-6C06F79A221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7968AF5-4D25-284C-C4AA-43CDD8F3CA7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E9E6094-8CAB-3B91-B6B7-80CCFD7B9581}"/>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6" name="Footer Placeholder 5">
            <a:extLst>
              <a:ext uri="{FF2B5EF4-FFF2-40B4-BE49-F238E27FC236}">
                <a16:creationId xmlns:a16="http://schemas.microsoft.com/office/drawing/2014/main" id="{90A3A2AE-41A8-1F31-516B-A486C6300F4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1576795-7D79-94C9-07FA-50CD011CD81B}"/>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12700921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4DAA84-91A6-3060-EE08-CF37E61CA72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67ED23-61B3-DC78-A806-39B78D00007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617B32E-3BE8-3887-7D04-E670C157CE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2AD25F4-12A4-52ED-C057-C30E40A36F29}"/>
              </a:ext>
            </a:extLst>
          </p:cNvPr>
          <p:cNvSpPr>
            <a:spLocks noGrp="1"/>
          </p:cNvSpPr>
          <p:nvPr>
            <p:ph type="dt" sz="half" idx="10"/>
          </p:nvPr>
        </p:nvSpPr>
        <p:spPr/>
        <p:txBody>
          <a:bodyPr/>
          <a:lstStyle/>
          <a:p>
            <a:fld id="{B5DCA51E-C30A-48E7-A5B0-05D1DD2A8B45}" type="datetimeFigureOut">
              <a:rPr lang="en-US" smtClean="0"/>
              <a:t>3/12/2024</a:t>
            </a:fld>
            <a:endParaRPr lang="en-US"/>
          </a:p>
        </p:txBody>
      </p:sp>
      <p:sp>
        <p:nvSpPr>
          <p:cNvPr id="6" name="Footer Placeholder 5">
            <a:extLst>
              <a:ext uri="{FF2B5EF4-FFF2-40B4-BE49-F238E27FC236}">
                <a16:creationId xmlns:a16="http://schemas.microsoft.com/office/drawing/2014/main" id="{68A2CB68-057D-58BA-2978-843C6E4799A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E04636A-50FE-F930-69F8-90DA5DE87A6F}"/>
              </a:ext>
            </a:extLst>
          </p:cNvPr>
          <p:cNvSpPr>
            <a:spLocks noGrp="1"/>
          </p:cNvSpPr>
          <p:nvPr>
            <p:ph type="sldNum" sz="quarter" idx="12"/>
          </p:nvPr>
        </p:nvSpPr>
        <p:spPr/>
        <p:txBody>
          <a:bodyPr/>
          <a:lstStyle/>
          <a:p>
            <a:fld id="{3CADE137-A749-48D4-ACB4-21EA0F15BE04}" type="slidenum">
              <a:rPr lang="en-US" smtClean="0"/>
              <a:t>‹#›</a:t>
            </a:fld>
            <a:endParaRPr lang="en-US"/>
          </a:p>
        </p:txBody>
      </p:sp>
    </p:spTree>
    <p:extLst>
      <p:ext uri="{BB962C8B-B14F-4D97-AF65-F5344CB8AC3E}">
        <p14:creationId xmlns:p14="http://schemas.microsoft.com/office/powerpoint/2010/main" val="37575869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12410A9-F3CB-78C0-697B-489EF59C2A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5302F9F-EB5D-5C5F-DCFA-9FCEE8F29B0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074764-E6E6-B3EC-D1F7-1D7EF8ECC5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DCA51E-C30A-48E7-A5B0-05D1DD2A8B45}" type="datetimeFigureOut">
              <a:rPr lang="en-US" smtClean="0"/>
              <a:t>3/12/2024</a:t>
            </a:fld>
            <a:endParaRPr lang="en-US"/>
          </a:p>
        </p:txBody>
      </p:sp>
      <p:sp>
        <p:nvSpPr>
          <p:cNvPr id="5" name="Footer Placeholder 4">
            <a:extLst>
              <a:ext uri="{FF2B5EF4-FFF2-40B4-BE49-F238E27FC236}">
                <a16:creationId xmlns:a16="http://schemas.microsoft.com/office/drawing/2014/main" id="{5B91FFF8-55EA-468C-CC96-160BBB34272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2B101D1-1242-892D-23FE-8AE80EB720E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ADE137-A749-48D4-ACB4-21EA0F15BE04}" type="slidenum">
              <a:rPr lang="en-US" smtClean="0"/>
              <a:t>‹#›</a:t>
            </a:fld>
            <a:endParaRPr lang="en-US"/>
          </a:p>
        </p:txBody>
      </p:sp>
    </p:spTree>
    <p:extLst>
      <p:ext uri="{BB962C8B-B14F-4D97-AF65-F5344CB8AC3E}">
        <p14:creationId xmlns:p14="http://schemas.microsoft.com/office/powerpoint/2010/main" val="10991279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a:extLst>
              <a:ext uri="{FF2B5EF4-FFF2-40B4-BE49-F238E27FC236}">
                <a16:creationId xmlns:a16="http://schemas.microsoft.com/office/drawing/2014/main" id="{59EB5FD1-9CEE-1585-1C83-7DB3BCD900BE}"/>
              </a:ext>
            </a:extLst>
          </p:cNvPr>
          <p:cNvSpPr txBox="1"/>
          <p:nvPr/>
        </p:nvSpPr>
        <p:spPr>
          <a:xfrm>
            <a:off x="97235" y="79135"/>
            <a:ext cx="11920594" cy="938719"/>
          </a:xfrm>
          <a:prstGeom prst="rect">
            <a:avLst/>
          </a:prstGeom>
          <a:noFill/>
        </p:spPr>
        <p:txBody>
          <a:bodyPr wrap="square" rtlCol="0">
            <a:spAutoFit/>
          </a:bodyPr>
          <a:lstStyle/>
          <a:p>
            <a:pPr algn="just"/>
            <a:r>
              <a:rPr lang="en-US" sz="1100" b="1" dirty="0">
                <a:latin typeface="Palatino Linotype" panose="02040502050505030304" pitchFamily="18" charset="0"/>
                <a:cs typeface="Times New Roman" panose="02020603050405020304" pitchFamily="18" charset="0"/>
              </a:rPr>
              <a:t>Supplementary figure S1. </a:t>
            </a:r>
            <a:r>
              <a:rPr lang="en-US" sz="1100" dirty="0">
                <a:latin typeface="Palatino Linotype" panose="02040502050505030304" pitchFamily="18" charset="0"/>
                <a:cs typeface="Times New Roman" panose="02020603050405020304" pitchFamily="18" charset="0"/>
              </a:rPr>
              <a:t>Hypothetical time tree showing the divergence times of </a:t>
            </a:r>
            <a:r>
              <a:rPr lang="en-US" sz="1100" dirty="0" err="1">
                <a:latin typeface="Palatino Linotype" panose="02040502050505030304" pitchFamily="18" charset="0"/>
                <a:cs typeface="Times New Roman" panose="02020603050405020304" pitchFamily="18" charset="0"/>
              </a:rPr>
              <a:t>lymphocryptoviruses</a:t>
            </a:r>
            <a:r>
              <a:rPr lang="en-US" sz="1100" dirty="0">
                <a:latin typeface="Palatino Linotype" panose="02040502050505030304" pitchFamily="18" charset="0"/>
                <a:cs typeface="Times New Roman" panose="02020603050405020304" pitchFamily="18" charset="0"/>
              </a:rPr>
              <a:t> (LCVs) from green monkeys (KNA-E4, -N6 and –R15, shown with black, pink, and red circles, respectively) and those of LCVs from other primates. The divergence time tree was estimated by the </a:t>
            </a:r>
            <a:r>
              <a:rPr lang="en-US" sz="1100" dirty="0" err="1">
                <a:latin typeface="Palatino Linotype" panose="02040502050505030304" pitchFamily="18" charset="0"/>
                <a:cs typeface="Times New Roman" panose="02020603050405020304" pitchFamily="18" charset="0"/>
              </a:rPr>
              <a:t>RelTime</a:t>
            </a:r>
            <a:r>
              <a:rPr lang="en-US" sz="1100" dirty="0">
                <a:latin typeface="Palatino Linotype" panose="02040502050505030304" pitchFamily="18" charset="0"/>
                <a:cs typeface="Times New Roman" panose="02020603050405020304" pitchFamily="18" charset="0"/>
              </a:rPr>
              <a:t> method embedded in MEGA11 software [60, 62], based on maximum likelihood analysis (using JTT + G model) of LCV partial DNA polymerase sequences (~ 635 amino acid residues). The viral time tree was calibrated based on the assumption that ancestors of LCVs infecting Old World Monkeys and New World Monkeys diverged along the same time frame as their ancestral non-human primate hosts (~ </a:t>
            </a:r>
            <a:r>
              <a:rPr lang="it-IT" sz="1100" dirty="0">
                <a:latin typeface="Palatino Linotype" panose="02040502050505030304" pitchFamily="18" charset="0"/>
                <a:cs typeface="Times New Roman" panose="02020603050405020304" pitchFamily="18" charset="0"/>
              </a:rPr>
              <a:t>43 million years ago (MYA), CI: 40.0 - 44.2 MYA [63])</a:t>
            </a:r>
            <a:r>
              <a:rPr lang="en-US" sz="1100" dirty="0">
                <a:latin typeface="Palatino Linotype" panose="02040502050505030304" pitchFamily="18" charset="0"/>
                <a:cs typeface="Times New Roman" panose="02020603050405020304" pitchFamily="18" charset="0"/>
              </a:rPr>
              <a:t>, as described previously [16]. A member of the genus </a:t>
            </a:r>
            <a:r>
              <a:rPr lang="en-US" sz="1100" i="1" dirty="0">
                <a:latin typeface="Palatino Linotype" panose="02040502050505030304" pitchFamily="18" charset="0"/>
                <a:cs typeface="Times New Roman" panose="02020603050405020304" pitchFamily="18" charset="0"/>
              </a:rPr>
              <a:t>Cytomegalovirus </a:t>
            </a:r>
            <a:r>
              <a:rPr lang="en-US" sz="1100" dirty="0">
                <a:latin typeface="Palatino Linotype" panose="02040502050505030304" pitchFamily="18" charset="0"/>
                <a:cs typeface="Times New Roman" panose="02020603050405020304" pitchFamily="18" charset="0"/>
              </a:rPr>
              <a:t>(CeBHV5/2715/Grivet monkey/FJ483968) was used as the outgroup sequence. </a:t>
            </a:r>
          </a:p>
        </p:txBody>
      </p:sp>
      <p:pic>
        <p:nvPicPr>
          <p:cNvPr id="10" name="Picture 9">
            <a:extLst>
              <a:ext uri="{FF2B5EF4-FFF2-40B4-BE49-F238E27FC236}">
                <a16:creationId xmlns:a16="http://schemas.microsoft.com/office/drawing/2014/main" id="{3844B63B-0C58-2111-CB69-3845506FDF20}"/>
              </a:ext>
            </a:extLst>
          </p:cNvPr>
          <p:cNvPicPr>
            <a:picLocks noChangeAspect="1"/>
          </p:cNvPicPr>
          <p:nvPr/>
        </p:nvPicPr>
        <p:blipFill>
          <a:blip r:embed="rId2"/>
          <a:stretch>
            <a:fillRect/>
          </a:stretch>
        </p:blipFill>
        <p:spPr>
          <a:xfrm>
            <a:off x="97235" y="1030015"/>
            <a:ext cx="12094766" cy="5000915"/>
          </a:xfrm>
          <a:prstGeom prst="rect">
            <a:avLst/>
          </a:prstGeom>
        </p:spPr>
      </p:pic>
    </p:spTree>
    <p:extLst>
      <p:ext uri="{BB962C8B-B14F-4D97-AF65-F5344CB8AC3E}">
        <p14:creationId xmlns:p14="http://schemas.microsoft.com/office/powerpoint/2010/main" val="152997373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9</TotalTime>
  <Words>170</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Palatino Linotype</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hosh, Souvik</dc:creator>
  <cp:lastModifiedBy>Ghosh, Souvik</cp:lastModifiedBy>
  <cp:revision>1</cp:revision>
  <dcterms:created xsi:type="dcterms:W3CDTF">2024-03-01T12:18:10Z</dcterms:created>
  <dcterms:modified xsi:type="dcterms:W3CDTF">2024-03-12T17:09:14Z</dcterms:modified>
</cp:coreProperties>
</file>